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135715382" r:id="rId2"/>
    <p:sldId id="2135715383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7"/>
    <p:restoredTop sz="96115"/>
  </p:normalViewPr>
  <p:slideViewPr>
    <p:cSldViewPr snapToGrid="0">
      <p:cViewPr varScale="1">
        <p:scale>
          <a:sx n="116" d="100"/>
          <a:sy n="116" d="100"/>
        </p:scale>
        <p:origin x="560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BA3CC9-3AAA-9300-121D-D0474C7B468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A27BAB6-8676-0BE5-E327-B0CC071D200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571CC3-BA0C-D07F-9AC9-B6006748C6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9CD6A-DB8E-2A46-B97B-81942582363E}" type="datetimeFigureOut">
              <a:rPr lang="en-US" smtClean="0"/>
              <a:t>4/18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B7A74F-3F56-6235-48BD-F1512B78D7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847672-E030-C0A9-59D4-0589A3BF35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F5D81-74B6-C04B-94ED-D8C6685529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63135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F0CEEF-6F7D-5680-32A4-91E4F06E52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7916B3C-2E87-9775-8CAC-59FC4D19F9F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0168EA-2F0C-E763-F396-7106792D87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9CD6A-DB8E-2A46-B97B-81942582363E}" type="datetimeFigureOut">
              <a:rPr lang="en-US" smtClean="0"/>
              <a:t>4/18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2C6F10-4958-38AC-70C6-00193C1072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0DB89C0-D3EB-3077-DF87-62CDCA7C87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F5D81-74B6-C04B-94ED-D8C6685529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26561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DDFDF4F-37A5-EE09-A0C8-23963369E6E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8539D5C-4AAA-7C14-5AE9-50DD225157F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552279-FEB1-67C5-927A-1536116B91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9CD6A-DB8E-2A46-B97B-81942582363E}" type="datetimeFigureOut">
              <a:rPr lang="en-US" smtClean="0"/>
              <a:t>4/18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EDF992-70B8-110B-3836-9142CF3134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79B3F4-7F3A-AC30-BA5A-454AF51C40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F5D81-74B6-C04B-94ED-D8C6685529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05574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536D3E-9A7D-FAEB-912E-2A3B33096E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1F23E87-1DD7-7C58-32E2-0ABEDDB4E68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8949CD-1A9C-C6FB-A479-1CDD7AC71B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9CD6A-DB8E-2A46-B97B-81942582363E}" type="datetimeFigureOut">
              <a:rPr lang="en-US" smtClean="0"/>
              <a:t>4/18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643A0E-B1AE-8EF0-F335-7BD6271CC1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20DBB9-C068-217C-AA7E-91CB4976C2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F5D81-74B6-C04B-94ED-D8C6685529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2549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0BA9CF-2B35-1A3C-85F0-514316FBB3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9C3E3D2-89F7-3862-EBE5-3C9E85407F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B008C0-3C43-4657-FF1A-FA3DD38FC9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9CD6A-DB8E-2A46-B97B-81942582363E}" type="datetimeFigureOut">
              <a:rPr lang="en-US" smtClean="0"/>
              <a:t>4/18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C3AE8C-C13F-29D7-3A40-B5243F42AF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4BE3EE-909B-5D59-FF9F-BC06F9069B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F5D81-74B6-C04B-94ED-D8C6685529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75070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D25C3A-F4E5-06CB-DFD4-37D5669859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37ABA3-8029-003F-D0AF-3D3A09CEB54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DC63A91-7E54-519E-5255-0F428DBCEB4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4420FF0-91A5-98C7-A9AA-674F1CBF22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9CD6A-DB8E-2A46-B97B-81942582363E}" type="datetimeFigureOut">
              <a:rPr lang="en-US" smtClean="0"/>
              <a:t>4/18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F1E82C7-6105-A574-C6E8-ABDC8E1A81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DCA4EDB-5A32-E797-2C1A-586C1D2A96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F5D81-74B6-C04B-94ED-D8C6685529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08865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ABCDDB-7DB7-066A-3120-E67DD62E2C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AE0E272-AFC8-477A-C0CE-00F9867082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A1481CE-4FDC-F59D-1522-877D46B9582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3D730B4-014F-05C4-A5C1-2FEC38C1ED3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6ED0A2D-3E0E-9A09-9CA0-462B9A6F2B4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BFEA0C6-E78B-E449-9F1C-BCED4EB743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9CD6A-DB8E-2A46-B97B-81942582363E}" type="datetimeFigureOut">
              <a:rPr lang="en-US" smtClean="0"/>
              <a:t>4/18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4025408-D115-4079-8B31-3C3161B378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E413B45-7BCF-5C26-CA2F-F2EAD87F21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F5D81-74B6-C04B-94ED-D8C6685529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63852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06EC0D-FEE1-DEDA-FED7-8B1417B1B6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D82CA3A-A65A-0092-D22E-B3357CED41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9CD6A-DB8E-2A46-B97B-81942582363E}" type="datetimeFigureOut">
              <a:rPr lang="en-US" smtClean="0"/>
              <a:t>4/18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008CC54-4723-DB47-BE80-6EB8562735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14FD78B-0301-76A4-9900-E683B08F60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F5D81-74B6-C04B-94ED-D8C6685529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76276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023484D-BFA8-B780-50C2-7E230103DC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9CD6A-DB8E-2A46-B97B-81942582363E}" type="datetimeFigureOut">
              <a:rPr lang="en-US" smtClean="0"/>
              <a:t>4/18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3828A6F-7C92-8B79-70CC-446F81ABB7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8BEF802-7E0C-AF24-4BEC-8CED0C0B13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F5D81-74B6-C04B-94ED-D8C6685529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68228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ADABB7-3E50-1C25-AB80-8E2FA811AD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93F90DE-9E88-6677-EC9D-D9A103EFCCD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3424B73-FA58-A776-6E02-0274CC53C03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94540FA-D871-B751-C048-E790F04114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9CD6A-DB8E-2A46-B97B-81942582363E}" type="datetimeFigureOut">
              <a:rPr lang="en-US" smtClean="0"/>
              <a:t>4/18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7447D2F-6324-631F-5389-F046986CE9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047FA4E-7B5A-75B6-4717-AA79D35AF1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F5D81-74B6-C04B-94ED-D8C6685529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96290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E72F49-734A-F2B5-71CC-C6DC8453B9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E3B347D-CA01-BA21-DBFA-40C2855D643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93898A2-D117-010D-4DD4-44EE9FDDEFD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2D64DAC-C2D7-5242-448C-5C7223F743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9CD6A-DB8E-2A46-B97B-81942582363E}" type="datetimeFigureOut">
              <a:rPr lang="en-US" smtClean="0"/>
              <a:t>4/18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B2429FE-5D7C-93C2-5457-9A20CAD497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79E717E-A160-750E-390E-05812EC00F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F5D81-74B6-C04B-94ED-D8C6685529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59856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1C64689-6B4C-8A38-BC17-F792C5195D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9B41539-D791-7CDA-A66E-FDBA550241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CFF67A-030E-0385-DF3C-6D66F29FCDC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E9CD6A-DB8E-2A46-B97B-81942582363E}" type="datetimeFigureOut">
              <a:rPr lang="en-US" smtClean="0"/>
              <a:t>4/18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E1B3F1-F618-9238-5422-4355F341C46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6A37D2-D8C7-098A-D450-B98D57CD15F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9F5D81-74B6-C04B-94ED-D8C6685529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14505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949307E6-5A85-BAC2-66E1-829C0F312CD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1559" y="676173"/>
            <a:ext cx="10785762" cy="125270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2AD6DFD7-91E7-19D1-060F-79FD97D21ED4}"/>
              </a:ext>
            </a:extLst>
          </p:cNvPr>
          <p:cNvSpPr txBox="1"/>
          <p:nvPr/>
        </p:nvSpPr>
        <p:spPr>
          <a:xfrm>
            <a:off x="144386" y="116208"/>
            <a:ext cx="368722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24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Supplemental Figure S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EAE70DE-E9B5-3ACA-4BA3-05E4CAEF2839}"/>
              </a:ext>
            </a:extLst>
          </p:cNvPr>
          <p:cNvSpPr txBox="1"/>
          <p:nvPr/>
        </p:nvSpPr>
        <p:spPr>
          <a:xfrm>
            <a:off x="144386" y="3084239"/>
            <a:ext cx="368722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24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Supplemental Figure S2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2C1308F6-C1EB-5458-2881-EDADBDC16AB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3703807"/>
            <a:ext cx="3007759" cy="300775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F96563F5-5016-D0E0-EC05-E03E08B3B4EA}"/>
              </a:ext>
            </a:extLst>
          </p:cNvPr>
          <p:cNvSpPr txBox="1"/>
          <p:nvPr/>
        </p:nvSpPr>
        <p:spPr>
          <a:xfrm>
            <a:off x="2031117" y="4019613"/>
            <a:ext cx="970137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S 0.63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ES 1.45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=0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DR q 0.65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9BB89700-3126-F6B5-9059-3C38BD80DC2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043718" y="3703807"/>
            <a:ext cx="3007759" cy="3007759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2F53C415-52AF-5408-6337-E27652DAAF83}"/>
              </a:ext>
            </a:extLst>
          </p:cNvPr>
          <p:cNvSpPr txBox="1"/>
          <p:nvPr/>
        </p:nvSpPr>
        <p:spPr>
          <a:xfrm>
            <a:off x="5081341" y="4019613"/>
            <a:ext cx="970137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S 0.56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ES 1.43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=0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DR q 0.48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F895BF0E-35AB-6743-3687-B7C192F67B7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87436" y="3703807"/>
            <a:ext cx="2989654" cy="2989654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9CBA8DE6-EB7A-F382-F6F1-3D4C7A090330}"/>
              </a:ext>
            </a:extLst>
          </p:cNvPr>
          <p:cNvSpPr txBox="1"/>
          <p:nvPr/>
        </p:nvSpPr>
        <p:spPr>
          <a:xfrm>
            <a:off x="8094752" y="4019613"/>
            <a:ext cx="970137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S 0.55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ES 1.36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=0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DR q 0.43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FC55EB52-6A39-C42D-F887-71BAA967AF4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113048" y="3715718"/>
            <a:ext cx="2977743" cy="2977743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2818094C-C32F-B58B-48F5-67752D95D8A3}"/>
              </a:ext>
            </a:extLst>
          </p:cNvPr>
          <p:cNvSpPr txBox="1"/>
          <p:nvPr/>
        </p:nvSpPr>
        <p:spPr>
          <a:xfrm>
            <a:off x="11141772" y="4019613"/>
            <a:ext cx="970137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S 0.48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ES 1.35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=0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DR q 0.40</a:t>
            </a:r>
          </a:p>
        </p:txBody>
      </p:sp>
    </p:spTree>
    <p:extLst>
      <p:ext uri="{BB962C8B-B14F-4D97-AF65-F5344CB8AC3E}">
        <p14:creationId xmlns:p14="http://schemas.microsoft.com/office/powerpoint/2010/main" val="34861141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0841FD54-6AF8-5798-B1DD-8948E96BEF7B}"/>
              </a:ext>
            </a:extLst>
          </p:cNvPr>
          <p:cNvSpPr txBox="1"/>
          <p:nvPr/>
        </p:nvSpPr>
        <p:spPr>
          <a:xfrm>
            <a:off x="585061" y="858832"/>
            <a:ext cx="368722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24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Supplemental Figure S3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024ECAA7-1315-901F-0440-93D4AF10C43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68172" y="1320497"/>
            <a:ext cx="5740400" cy="5181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902568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9</Words>
  <Application>Microsoft Macintosh PowerPoint</Application>
  <PresentationFormat>Widescreen</PresentationFormat>
  <Paragraphs>19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Xie, Changqing (NIH/NCI) [E]</dc:creator>
  <cp:lastModifiedBy>Xie, Changqing (NIH/NCI) [E]</cp:lastModifiedBy>
  <cp:revision>1</cp:revision>
  <dcterms:created xsi:type="dcterms:W3CDTF">2023-04-18T14:52:01Z</dcterms:created>
  <dcterms:modified xsi:type="dcterms:W3CDTF">2023-04-18T14:52:34Z</dcterms:modified>
</cp:coreProperties>
</file>